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90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18847A-1850-7AFC-B1E6-C075064D17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7841350-C11F-238A-332C-9FA216ACCD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631E32-5013-3538-4FC7-45DC4EBE1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F90027-A7D1-3630-C638-9D72C2162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1D7C21-43CB-EAD2-80BA-DACDB6E36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4427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15DFE5-F901-FAF2-08C2-09360C38D4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5CD2EEB-D82F-CEE5-2F8A-0C4E9B9F24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7E400B-D202-E498-D1B9-222E3B0C7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F695FB-6FFB-E4B5-93FE-80DEA0BAE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40B0539-017F-5EB1-3ABB-BFF467DAE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630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E7FF350-E320-CE69-4A34-7A2E11FC09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9863BAB-B15A-6455-65DF-F9368A0906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4861F31-73DD-B6CF-FA8D-C9182A3FC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A59275-C1CD-CD65-CC2C-2DAB06D59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CE4CD9-31E9-7F13-4572-E9178CB59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9337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B91594-3B90-1E52-2086-40842F57B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1D3373D-AF53-C195-1B9D-9575A09B5D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AF3ED7-9FD3-60C4-59C3-6BFC8EEB5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F11E3A-581A-0039-0C87-C02B1BD0C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54A8FA-017B-28BF-D044-2E7415379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2364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FD5CF0-66E2-345A-39FE-975E704DCF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F0C3F54-06F7-BFE1-019B-FB00E404A2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C01A17-C4C7-A998-804A-0FF4FDE71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E97429-027C-EF33-0CE0-0FB470F46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A67600-2FE3-AD0F-384E-AF02E0026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2321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210387-2035-35C9-8113-C64A16CA8C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3ECF8E-C922-15E6-C342-2DEA630427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C2FD00C-2CDC-9B53-D56B-5E934D2D74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6FF5158-071B-3406-080B-CC1655FDC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18FAF55-A4DC-CBE7-FCF9-D71F1C387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B551622-46C6-5CD8-B7DB-B5A1B21D8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8249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27FC52-93AA-1230-58C4-253C8A314C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3BD63C5-833C-A166-A8B2-B861AE6682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AFCC94B-4983-550D-E108-677DA4A51B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2FD3630-4FCE-2022-4E4B-7091BCD79A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A77FD9B-0F50-0E9F-B7AB-DFDB5619B7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F95FDC4-D08D-318A-CF9C-256672338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FFF6CA5-4BC1-DE20-FF71-296304FD6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6FE1FF1-4821-68F6-B559-06FAC5C0A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6354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0C0BFF-9CEE-575E-D4E1-EF6534A3EF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DC44F61-CD44-42D5-97B2-08261CC66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9365EF2-B266-B531-85DA-E2AA2C9DF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64D6FAE-7C25-E4E1-10FD-A60F17FEE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4992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C325975-024F-06D2-9CDE-6EC68F6CB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71FBB40-0C69-C874-4993-B061B1A47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29EBEA8-2932-9FC4-37C4-DDF48D0BE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0937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512F68-4FC5-049C-A8E7-40C03B8404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A6D4D57-3338-4DD0-9BE1-4B21BA0D9F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5655687-8E68-BB28-D9DA-951F69E9D2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912E66-4D8F-4F10-A456-A365D6797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730C5C8-D535-6CF9-875B-8827237A7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B3728CB-BED6-FDA6-D3A9-D85C4BCA8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4196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FFB384-6C2F-C167-3B34-4BD6B91485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1945D5D-DFB0-8932-6210-FD22D04154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233B1E9-0150-658D-5B85-BCFB8B8A73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DE27C66-C90A-F630-9B2E-39C5433F7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12E5098-1BB4-FF22-5F55-461387FFF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6A83F18-E2E3-368F-BFFC-C85EBDE2B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2457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82AF14B-5B5C-CFCA-D8EF-A47F65C924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8EB8A7C-465F-D737-F3FD-DFCB954BBD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CD239C-47EB-B63B-3E3F-6072B573E5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C27C90-2434-4F79-BB84-FE413A9A9AF6}" type="datetimeFigureOut">
              <a:rPr lang="zh-CN" altLang="en-US" smtClean="0"/>
              <a:t>2022/6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DE5169-9329-2785-5B4A-7B00F5F1BF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174602-B4AF-4F1B-E84B-04CBBDC9F1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6AB74-1204-4216-88DF-B0FF02D1B5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588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hyperlink" Target="https://npgsweb.ars-grin.gov/" TargetMode="Externa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9F7186F3-05EB-239B-7F83-CA69F82DC2FC}"/>
              </a:ext>
            </a:extLst>
          </p:cNvPr>
          <p:cNvGrpSpPr/>
          <p:nvPr/>
        </p:nvGrpSpPr>
        <p:grpSpPr>
          <a:xfrm>
            <a:off x="132347" y="321125"/>
            <a:ext cx="12059653" cy="5484682"/>
            <a:chOff x="0" y="252663"/>
            <a:chExt cx="10820832" cy="3917887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A8D8CA55-4165-9A4D-8C18-2996DB46ECBD}"/>
                </a:ext>
              </a:extLst>
            </p:cNvPr>
            <p:cNvGrpSpPr/>
            <p:nvPr/>
          </p:nvGrpSpPr>
          <p:grpSpPr>
            <a:xfrm>
              <a:off x="0" y="252664"/>
              <a:ext cx="8313821" cy="3704851"/>
              <a:chOff x="0" y="252664"/>
              <a:chExt cx="11543110" cy="5047059"/>
            </a:xfrm>
          </p:grpSpPr>
          <p:pic>
            <p:nvPicPr>
              <p:cNvPr id="8" name="Picture 2">
                <a:extLst>
                  <a:ext uri="{FF2B5EF4-FFF2-40B4-BE49-F238E27FC236}">
                    <a16:creationId xmlns:a16="http://schemas.microsoft.com/office/drawing/2014/main" id="{56626963-081A-9B1B-4961-A7FA0667DE8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252664"/>
                <a:ext cx="3940777" cy="440355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69338717-7702-5A0C-2349-78B64E20978E}"/>
                  </a:ext>
                </a:extLst>
              </p:cNvPr>
              <p:cNvSpPr txBox="1"/>
              <p:nvPr/>
            </p:nvSpPr>
            <p:spPr>
              <a:xfrm>
                <a:off x="193136" y="4656220"/>
                <a:ext cx="2624505" cy="62896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tr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4204</a:t>
                </a:r>
              </a:p>
              <a:p>
                <a:pPr algn="ctr"/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ype1, 1=ABSENT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0" name="Picture 4">
                <a:extLst>
                  <a:ext uri="{FF2B5EF4-FFF2-40B4-BE49-F238E27FC236}">
                    <a16:creationId xmlns:a16="http://schemas.microsoft.com/office/drawing/2014/main" id="{2928075E-60BD-7BB2-77D7-868CDCAD69C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813"/>
              <a:stretch/>
            </p:blipFill>
            <p:spPr bwMode="auto">
              <a:xfrm>
                <a:off x="3940775" y="252664"/>
                <a:ext cx="3869774" cy="440355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CC97EB4B-F823-9EA8-D9A1-E171B1DA3F68}"/>
                  </a:ext>
                </a:extLst>
              </p:cNvPr>
              <p:cNvSpPr txBox="1"/>
              <p:nvPr/>
            </p:nvSpPr>
            <p:spPr>
              <a:xfrm>
                <a:off x="3940775" y="4670763"/>
                <a:ext cx="3188073" cy="62896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b="0" i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 223151</a:t>
                </a:r>
              </a:p>
              <a:p>
                <a:pPr algn="ctr"/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ype2, 3=EDGE ONLY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2" name="Picture 6">
                <a:extLst>
                  <a:ext uri="{FF2B5EF4-FFF2-40B4-BE49-F238E27FC236}">
                    <a16:creationId xmlns:a16="http://schemas.microsoft.com/office/drawing/2014/main" id="{A7C0885F-DC49-5902-6019-87C42BDA91B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881552" y="252664"/>
                <a:ext cx="3661558" cy="440355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2F26A41D-7E4A-49EE-3E92-AA0C6CA1FC06}"/>
                  </a:ext>
                </a:extLst>
              </p:cNvPr>
              <p:cNvSpPr txBox="1"/>
              <p:nvPr/>
            </p:nvSpPr>
            <p:spPr>
              <a:xfrm>
                <a:off x="7810549" y="4656220"/>
                <a:ext cx="3377209" cy="62896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b="0" i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 445734</a:t>
                </a:r>
              </a:p>
              <a:p>
                <a:pPr algn="ctr"/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ype3, 5=SHORT (FINE)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6" name="Picture 2">
              <a:extLst>
                <a:ext uri="{FF2B5EF4-FFF2-40B4-BE49-F238E27FC236}">
                  <a16:creationId xmlns:a16="http://schemas.microsoft.com/office/drawing/2014/main" id="{E9092C56-403C-B1D7-EE07-02F454A54B2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486" t="6188" r="1486"/>
            <a:stretch/>
          </p:blipFill>
          <p:spPr bwMode="auto">
            <a:xfrm>
              <a:off x="8364960" y="252663"/>
              <a:ext cx="2238902" cy="32324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1424AA4D-4935-78C7-E7A4-D93C058A68FD}"/>
                </a:ext>
              </a:extLst>
            </p:cNvPr>
            <p:cNvSpPr txBox="1"/>
            <p:nvPr/>
          </p:nvSpPr>
          <p:spPr>
            <a:xfrm>
              <a:off x="8208301" y="3495820"/>
              <a:ext cx="2612531" cy="6747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b="0" i="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I 225271</a:t>
              </a:r>
            </a:p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ype4, 9=LONG, READILY VISIBL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11BE71D6-2371-D75F-163F-8E7045A5FF32}"/>
              </a:ext>
            </a:extLst>
          </p:cNvPr>
          <p:cNvSpPr txBox="1"/>
          <p:nvPr/>
        </p:nvSpPr>
        <p:spPr>
          <a:xfrm>
            <a:off x="287377" y="5938063"/>
            <a:ext cx="1164724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1 The glume pubescence spike images for four types of </a:t>
            </a:r>
            <a:r>
              <a:rPr lang="en-US" altLang="zh-CN" sz="18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p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images were download from GRIN database (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hlinkClick r:id="rId6"/>
              </a:rPr>
              <a:t>https://npgsweb.ars-grin.gov/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,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ype1</a:t>
            </a: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=ABSENT; Type2, 3=EDGE ONLY, Type3, 5=SHORT (FINE), Type3, 9=LONG, READILY VISIBLE</a:t>
            </a:r>
            <a:endParaRPr lang="zh-CN" altLang="zh-CN" sz="18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4143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94</Words>
  <Application>Microsoft Office PowerPoint</Application>
  <PresentationFormat>宽屏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 Hu</dc:creator>
  <cp:lastModifiedBy>Xin Hu</cp:lastModifiedBy>
  <cp:revision>4</cp:revision>
  <dcterms:created xsi:type="dcterms:W3CDTF">2022-05-06T08:50:30Z</dcterms:created>
  <dcterms:modified xsi:type="dcterms:W3CDTF">2022-06-16T08:56:37Z</dcterms:modified>
</cp:coreProperties>
</file>